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8" d="100"/>
          <a:sy n="108" d="100"/>
        </p:scale>
        <p:origin x="-2504" y="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A9A010-6F19-7A46-A0C9-18569CF4D4A8}" type="datetimeFigureOut">
              <a:rPr lang="en-US" smtClean="0"/>
              <a:t>8/9/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79A2A9-E2DC-324B-9D61-7A2BBE2AF7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8946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817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8823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576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9590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435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769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176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192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9492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614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7229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F71330-4384-EB4A-8059-C3690F3578F4}" type="datetimeFigureOut">
              <a:rPr lang="en-US" smtClean="0"/>
              <a:t>8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E399D6-327D-E34F-8B2B-7DC1B1F1F2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865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jpeg"/><Relationship Id="rId12" Type="http://schemas.openxmlformats.org/officeDocument/2006/relationships/image" Target="../media/image11.jpg"/><Relationship Id="rId13" Type="http://schemas.openxmlformats.org/officeDocument/2006/relationships/image" Target="../media/image12.jpg"/><Relationship Id="rId14" Type="http://schemas.openxmlformats.org/officeDocument/2006/relationships/image" Target="../media/image13.jpg"/><Relationship Id="rId15" Type="http://schemas.openxmlformats.org/officeDocument/2006/relationships/image" Target="../media/image14.jpg"/><Relationship Id="rId16" Type="http://schemas.openxmlformats.org/officeDocument/2006/relationships/image" Target="../media/image15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jpeg"/><Relationship Id="rId7" Type="http://schemas.openxmlformats.org/officeDocument/2006/relationships/image" Target="../media/image6.jpeg"/><Relationship Id="rId8" Type="http://schemas.openxmlformats.org/officeDocument/2006/relationships/image" Target="../media/image7.jpeg"/><Relationship Id="rId9" Type="http://schemas.openxmlformats.org/officeDocument/2006/relationships/image" Target="../media/image8.jpeg"/><Relationship Id="rId10" Type="http://schemas.openxmlformats.org/officeDocument/2006/relationships/image" Target="../media/image9.jpeg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5.jpg"/><Relationship Id="rId12" Type="http://schemas.openxmlformats.org/officeDocument/2006/relationships/image" Target="../media/image26.jpg"/><Relationship Id="rId13" Type="http://schemas.openxmlformats.org/officeDocument/2006/relationships/image" Target="../media/image27.jpg"/><Relationship Id="rId14" Type="http://schemas.openxmlformats.org/officeDocument/2006/relationships/image" Target="../media/image28.jpg"/><Relationship Id="rId15" Type="http://schemas.openxmlformats.org/officeDocument/2006/relationships/image" Target="../media/image29.jpg"/><Relationship Id="rId16" Type="http://schemas.openxmlformats.org/officeDocument/2006/relationships/image" Target="../media/image30.jpg"/><Relationship Id="rId17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jpeg"/><Relationship Id="rId3" Type="http://schemas.openxmlformats.org/officeDocument/2006/relationships/image" Target="../media/image17.jpeg"/><Relationship Id="rId4" Type="http://schemas.openxmlformats.org/officeDocument/2006/relationships/image" Target="../media/image18.jpeg"/><Relationship Id="rId5" Type="http://schemas.openxmlformats.org/officeDocument/2006/relationships/image" Target="../media/image19.jpeg"/><Relationship Id="rId6" Type="http://schemas.openxmlformats.org/officeDocument/2006/relationships/image" Target="../media/image20.jpeg"/><Relationship Id="rId7" Type="http://schemas.openxmlformats.org/officeDocument/2006/relationships/image" Target="../media/image21.jpeg"/><Relationship Id="rId8" Type="http://schemas.openxmlformats.org/officeDocument/2006/relationships/image" Target="../media/image22.jpeg"/><Relationship Id="rId9" Type="http://schemas.openxmlformats.org/officeDocument/2006/relationships/image" Target="../media/image23.jpeg"/><Relationship Id="rId10" Type="http://schemas.openxmlformats.org/officeDocument/2006/relationships/image" Target="../media/image2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>
          <a:xfrm>
            <a:off x="3884613" y="8955670"/>
            <a:ext cx="2971800" cy="457200"/>
          </a:xfrm>
        </p:spPr>
        <p:txBody>
          <a:bodyPr/>
          <a:lstStyle/>
          <a:p>
            <a:fld id="{2A545166-490B-FF4E-AF3C-A17AE7072E8F}" type="slidenum">
              <a:rPr lang="en-US" smtClean="0"/>
              <a:t>1</a:t>
            </a:fld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2057400" y="460030"/>
            <a:ext cx="121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Le-V-ASC</a:t>
            </a:r>
            <a:endParaRPr lang="en-US" sz="1400" dirty="0"/>
          </a:p>
        </p:txBody>
      </p:sp>
      <p:sp>
        <p:nvSpPr>
          <p:cNvPr id="6" name="TextBox 5"/>
          <p:cNvSpPr txBox="1"/>
          <p:nvPr/>
        </p:nvSpPr>
        <p:spPr>
          <a:xfrm>
            <a:off x="457200" y="482333"/>
            <a:ext cx="121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Le-SC-ASC</a:t>
            </a:r>
            <a:endParaRPr lang="en-US" sz="1400" dirty="0"/>
          </a:p>
        </p:txBody>
      </p:sp>
      <p:sp>
        <p:nvSpPr>
          <p:cNvPr id="7" name="TextBox 6"/>
          <p:cNvSpPr txBox="1"/>
          <p:nvPr/>
        </p:nvSpPr>
        <p:spPr>
          <a:xfrm>
            <a:off x="5334000" y="455909"/>
            <a:ext cx="121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Ob-V-ASC</a:t>
            </a:r>
            <a:endParaRPr lang="en-US" sz="1400" dirty="0"/>
          </a:p>
        </p:txBody>
      </p:sp>
      <p:sp>
        <p:nvSpPr>
          <p:cNvPr id="8" name="TextBox 7"/>
          <p:cNvSpPr txBox="1"/>
          <p:nvPr/>
        </p:nvSpPr>
        <p:spPr>
          <a:xfrm>
            <a:off x="3733800" y="482333"/>
            <a:ext cx="121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Ob-SC-ASC</a:t>
            </a:r>
            <a:endParaRPr lang="en-US" sz="1400" dirty="0"/>
          </a:p>
        </p:txBody>
      </p:sp>
      <p:pic>
        <p:nvPicPr>
          <p:cNvPr id="9" name="Picture 37" descr="C:\Users\TNSolley\Desktop\Le-SC-ASC_CD29-PE-Cy7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63"/>
          <a:stretch/>
        </p:blipFill>
        <p:spPr bwMode="auto">
          <a:xfrm>
            <a:off x="76200" y="814734"/>
            <a:ext cx="1581150" cy="161501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8" descr="C:\Users\TNSolley\Desktop\Le-V-ASC_CD29-PE-Cy7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90676" y="814733"/>
            <a:ext cx="1781175" cy="1700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39" descr="C:\Users\TNSolley\Desktop\Ob-SC-ASC_CD29-PE-Cy7.jp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3677" y="824430"/>
            <a:ext cx="1679811" cy="159561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40" descr="C:\Users\TNSolley\Desktop\Ob-V-ASC_CD29-PE-Cy7.jp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43488" y="823321"/>
            <a:ext cx="1685925" cy="16178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3124200" y="2163398"/>
            <a:ext cx="121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D29</a:t>
            </a:r>
            <a:endParaRPr lang="en-US" sz="1400" dirty="0"/>
          </a:p>
        </p:txBody>
      </p:sp>
      <p:pic>
        <p:nvPicPr>
          <p:cNvPr id="14" name="Picture 2" descr="S:\Division\Dept. Rad Oncology\Klopp Lab\Mouse Stem Cells characterization\Cell marker expression\yan Zhang FCM FCS file\L_SQ_ASC_CD34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92" t="1600"/>
          <a:stretch/>
        </p:blipFill>
        <p:spPr bwMode="auto">
          <a:xfrm>
            <a:off x="1" y="2635328"/>
            <a:ext cx="1738401" cy="17579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3" descr="S:\Division\Dept. Rad Oncology\Klopp Lab\Mouse Stem Cells characterization\Cell marker expression\yan Zhang FCM FCS file\L_V_ASC_CD34.jpg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1" t="4335"/>
          <a:stretch/>
        </p:blipFill>
        <p:spPr bwMode="auto">
          <a:xfrm>
            <a:off x="1738401" y="2711528"/>
            <a:ext cx="1756494" cy="16817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4" descr="S:\Division\Dept. Rad Oncology\Klopp Lab\Mouse Stem Cells characterization\Cell marker expression\yan Zhang FCM FCS file\O_SQ_CD34.jpg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26" r="2883" b="3968"/>
          <a:stretch/>
        </p:blipFill>
        <p:spPr bwMode="auto">
          <a:xfrm>
            <a:off x="3469376" y="2635328"/>
            <a:ext cx="1686705" cy="173408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3135076" y="4184747"/>
            <a:ext cx="121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D34</a:t>
            </a:r>
            <a:endParaRPr lang="en-US" sz="1400" dirty="0"/>
          </a:p>
        </p:txBody>
      </p:sp>
      <p:pic>
        <p:nvPicPr>
          <p:cNvPr id="18" name="Picture 6" descr="S:\Division\Dept. Rad Oncology\Klopp Lab\Mouse Stem Cells characterization\Cell marker expression\yan Zhang FCM FCS file\L-SQ_CD31.jpg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39" t="-1" r="4293" b="4331"/>
          <a:stretch/>
        </p:blipFill>
        <p:spPr bwMode="auto">
          <a:xfrm>
            <a:off x="33339" y="4645654"/>
            <a:ext cx="1633536" cy="17308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7" descr="S:\Division\Dept. Rad Oncology\Klopp Lab\Mouse Stem Cells characterization\Cell marker expression\yan Zhang FCM FCS file\O_V_ASC_CD31.jpg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2" t="2535" r="48626" b="580"/>
          <a:stretch/>
        </p:blipFill>
        <p:spPr bwMode="auto">
          <a:xfrm>
            <a:off x="1685925" y="4650870"/>
            <a:ext cx="1646046" cy="174580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" name="Picture 8" descr="S:\Division\Dept. Rad Oncology\Klopp Lab\Mouse Stem Cells characterization\Cell marker expression\yan Zhang FCM FCS file\O-SQ_CD31.jpg"/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39" t="2128" r="2272" b="4255"/>
          <a:stretch/>
        </p:blipFill>
        <p:spPr bwMode="auto">
          <a:xfrm>
            <a:off x="3363677" y="4675276"/>
            <a:ext cx="1721749" cy="17217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" name="Picture 9" descr="S:\Division\Dept. Rad Oncology\Klopp Lab\Mouse Stem Cells characterization\Cell marker expression\yan Zhang FCM FCS file\O_V_ASC_CD31.jpg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13" t="4156" r="50401" b="4416"/>
          <a:stretch/>
        </p:blipFill>
        <p:spPr bwMode="auto">
          <a:xfrm>
            <a:off x="5189068" y="4651958"/>
            <a:ext cx="1649882" cy="1688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TextBox 21"/>
          <p:cNvSpPr txBox="1"/>
          <p:nvPr/>
        </p:nvSpPr>
        <p:spPr>
          <a:xfrm>
            <a:off x="3057944" y="6212010"/>
            <a:ext cx="121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D31</a:t>
            </a:r>
            <a:endParaRPr lang="en-US" sz="1400" dirty="0"/>
          </a:p>
        </p:txBody>
      </p:sp>
      <p:pic>
        <p:nvPicPr>
          <p:cNvPr id="28" name="Picture 27" descr="Ob-V-ASC CD34 082213.jpg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47" t="2684" r="3219" b="4924"/>
          <a:stretch/>
        </p:blipFill>
        <p:spPr>
          <a:xfrm>
            <a:off x="5115059" y="2711528"/>
            <a:ext cx="1703571" cy="1681743"/>
          </a:xfrm>
          <a:prstGeom prst="rect">
            <a:avLst/>
          </a:prstGeom>
        </p:spPr>
      </p:pic>
      <p:sp>
        <p:nvSpPr>
          <p:cNvPr id="29" name="Rectangle 28"/>
          <p:cNvSpPr/>
          <p:nvPr/>
        </p:nvSpPr>
        <p:spPr>
          <a:xfrm>
            <a:off x="-72380" y="-10506"/>
            <a:ext cx="689100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1 Fig. </a:t>
            </a:r>
            <a:r>
              <a:rPr lang="en-US" dirty="0"/>
              <a:t>Flow </a:t>
            </a:r>
            <a:r>
              <a:rPr lang="en-US" dirty="0" err="1"/>
              <a:t>cytometric</a:t>
            </a:r>
            <a:r>
              <a:rPr lang="en-US" dirty="0"/>
              <a:t> characterization of ASC based </a:t>
            </a:r>
            <a:r>
              <a:rPr lang="en-US" dirty="0" smtClean="0"/>
              <a:t>on surface </a:t>
            </a:r>
            <a:r>
              <a:rPr lang="en-US" dirty="0"/>
              <a:t>marker </a:t>
            </a:r>
            <a:r>
              <a:rPr lang="en-US" dirty="0" smtClean="0"/>
              <a:t>     expression </a:t>
            </a:r>
            <a:endParaRPr lang="en-US" b="1" dirty="0"/>
          </a:p>
        </p:txBody>
      </p:sp>
      <p:pic>
        <p:nvPicPr>
          <p:cNvPr id="3" name="Picture 2" descr="CD11B Le-V.jpg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13" t="7353" r="6333" b="5152"/>
          <a:stretch/>
        </p:blipFill>
        <p:spPr>
          <a:xfrm>
            <a:off x="1444782" y="6630617"/>
            <a:ext cx="1887189" cy="1864936"/>
          </a:xfrm>
          <a:prstGeom prst="rect">
            <a:avLst/>
          </a:prstGeom>
        </p:spPr>
      </p:pic>
      <p:pic>
        <p:nvPicPr>
          <p:cNvPr id="2" name="Picture 1" descr="CD11b-LeSC.jpg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03" t="15055" r="62816" b="3722"/>
          <a:stretch/>
        </p:blipFill>
        <p:spPr>
          <a:xfrm>
            <a:off x="1" y="6711897"/>
            <a:ext cx="1590676" cy="1604753"/>
          </a:xfrm>
          <a:prstGeom prst="rect">
            <a:avLst/>
          </a:prstGeom>
        </p:spPr>
      </p:pic>
      <p:pic>
        <p:nvPicPr>
          <p:cNvPr id="24" name="Picture 23" descr="CD11b-ObSC.jp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48" t="7994" r="4088" b="3840"/>
          <a:stretch/>
        </p:blipFill>
        <p:spPr>
          <a:xfrm>
            <a:off x="3423848" y="6737787"/>
            <a:ext cx="1625734" cy="1642298"/>
          </a:xfrm>
          <a:prstGeom prst="rect">
            <a:avLst/>
          </a:prstGeom>
        </p:spPr>
      </p:pic>
      <p:pic>
        <p:nvPicPr>
          <p:cNvPr id="30" name="Picture 29" descr="CD11B ObV.jpg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98" t="7871" r="4641" b="4062"/>
          <a:stretch/>
        </p:blipFill>
        <p:spPr>
          <a:xfrm>
            <a:off x="5054601" y="6768268"/>
            <a:ext cx="1604688" cy="1642298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3057944" y="8288645"/>
            <a:ext cx="1219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D11b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110631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057400" y="189571"/>
            <a:ext cx="1219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Le-V-ASC</a:t>
            </a:r>
            <a:endParaRPr lang="en-US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457200" y="211873"/>
            <a:ext cx="1219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Le-SC-ASC</a:t>
            </a:r>
            <a:endParaRPr lang="en-US" sz="1600" dirty="0"/>
          </a:p>
        </p:txBody>
      </p:sp>
      <p:sp>
        <p:nvSpPr>
          <p:cNvPr id="8" name="TextBox 7"/>
          <p:cNvSpPr txBox="1"/>
          <p:nvPr/>
        </p:nvSpPr>
        <p:spPr>
          <a:xfrm>
            <a:off x="5344160" y="214354"/>
            <a:ext cx="1219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Ob-V-ASC</a:t>
            </a:r>
            <a:endParaRPr lang="en-US" sz="1600" dirty="0"/>
          </a:p>
        </p:txBody>
      </p:sp>
      <p:sp>
        <p:nvSpPr>
          <p:cNvPr id="9" name="TextBox 8"/>
          <p:cNvSpPr txBox="1"/>
          <p:nvPr/>
        </p:nvSpPr>
        <p:spPr>
          <a:xfrm>
            <a:off x="3733800" y="211873"/>
            <a:ext cx="12192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Ob-SC-ASC</a:t>
            </a:r>
            <a:endParaRPr lang="en-US" sz="1600" dirty="0"/>
          </a:p>
        </p:txBody>
      </p:sp>
      <p:pic>
        <p:nvPicPr>
          <p:cNvPr id="10" name="Picture 3" descr="S:\Division\Dept. Rad Oncology\Klopp Lab\Mouse Stem Cells characterization\Cell marker expression\yan Zhang FCM FCS file\Le-V_CD73.jpg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01" t="4233" r="3030" b="4762"/>
          <a:stretch/>
        </p:blipFill>
        <p:spPr bwMode="auto">
          <a:xfrm>
            <a:off x="1828800" y="704850"/>
            <a:ext cx="1428751" cy="14287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4" descr="S:\Division\Dept. Rad Oncology\Klopp Lab\Mouse Stem Cells characterization\Cell marker expression\yan Zhang FCM FCS file\O_SC_CD73.jpg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83" t="5491" r="4371" b="4335"/>
          <a:stretch/>
        </p:blipFill>
        <p:spPr bwMode="auto">
          <a:xfrm>
            <a:off x="3362324" y="685801"/>
            <a:ext cx="1657350" cy="16573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3048000" y="2025134"/>
            <a:ext cx="685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CD73</a:t>
            </a:r>
            <a:endParaRPr lang="en-US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3171825" y="4038600"/>
            <a:ext cx="6858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CD90</a:t>
            </a:r>
            <a:endParaRPr lang="en-US" sz="1600" dirty="0"/>
          </a:p>
        </p:txBody>
      </p:sp>
      <p:sp>
        <p:nvSpPr>
          <p:cNvPr id="19" name="TextBox 18"/>
          <p:cNvSpPr txBox="1"/>
          <p:nvPr/>
        </p:nvSpPr>
        <p:spPr>
          <a:xfrm>
            <a:off x="3190874" y="6017726"/>
            <a:ext cx="10001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CD105</a:t>
            </a:r>
            <a:endParaRPr lang="en-US" sz="1600" dirty="0"/>
          </a:p>
        </p:txBody>
      </p:sp>
      <p:pic>
        <p:nvPicPr>
          <p:cNvPr id="22" name="Picture 12" descr="S:\Division\Dept. Rad Oncology\Klopp Lab\Mouse Stem Cells characterization\Cell marker expression\yan Zhang FCM FCS file\O_V_ASC_CD73.jpg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399" t="3979" r="2381" b="4774"/>
          <a:stretch/>
        </p:blipFill>
        <p:spPr bwMode="auto">
          <a:xfrm>
            <a:off x="5143501" y="685799"/>
            <a:ext cx="1676400" cy="1638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3" descr="S:\Division\Dept. Rad Oncology\Klopp Lab\Mouse Stem Cells characterization\Cell marker expression\yan Zhang FCM FCS file\Le-SC_CD73.jpg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24" t="2925" r="3526" b="5585"/>
          <a:stretch/>
        </p:blipFill>
        <p:spPr bwMode="auto">
          <a:xfrm>
            <a:off x="142876" y="638177"/>
            <a:ext cx="1571625" cy="15716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2" descr="S:\Division\Dept. Rad Oncology\Klopp Lab\Mouse Stem Cells characterization\Cell marker expression\yan Zhang FCM FCS file\O-V_ASC_CD45.jpg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94" t="3439" r="3417" b="5555"/>
          <a:stretch/>
        </p:blipFill>
        <p:spPr bwMode="auto">
          <a:xfrm>
            <a:off x="5181600" y="6391275"/>
            <a:ext cx="1638300" cy="16383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3" descr="S:\Division\Dept. Rad Oncology\Klopp Lab\Mouse Stem Cells characterization\Cell marker expression\yan Zhang FCM FCS file\O_SQ_ASC_CD45.jpg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586" t="4233" r="2525" b="4762"/>
          <a:stretch/>
        </p:blipFill>
        <p:spPr bwMode="auto">
          <a:xfrm>
            <a:off x="3514725" y="6410326"/>
            <a:ext cx="1676400" cy="16383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6" name="Picture 4" descr="S:\Division\Dept. Rad Oncology\Klopp Lab\Mouse Stem Cells characterization\Cell marker expression\yan Zhang FCM FCS file\Le_SQ_CD45.jpg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89" t="4210" r="1759" b="5264"/>
          <a:stretch/>
        </p:blipFill>
        <p:spPr bwMode="auto">
          <a:xfrm>
            <a:off x="29127" y="6419851"/>
            <a:ext cx="1594884" cy="1524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Picture 5" descr="S:\Division\Dept. Rad Oncology\Klopp Lab\Mouse Stem Cells characterization\Cell marker expression\yan Zhang FCM FCS file\L-V_ASC_CD45.jpg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58" t="3826" r="3980" b="5409"/>
          <a:stretch/>
        </p:blipFill>
        <p:spPr bwMode="auto">
          <a:xfrm>
            <a:off x="1638301" y="6404265"/>
            <a:ext cx="1743075" cy="170345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TextBox 27"/>
          <p:cNvSpPr txBox="1"/>
          <p:nvPr/>
        </p:nvSpPr>
        <p:spPr>
          <a:xfrm>
            <a:off x="3190874" y="8048626"/>
            <a:ext cx="10001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CD45</a:t>
            </a:r>
            <a:endParaRPr lang="en-US" sz="1600" dirty="0"/>
          </a:p>
        </p:txBody>
      </p:sp>
      <p:pic>
        <p:nvPicPr>
          <p:cNvPr id="2" name="Picture 1" descr="CD90-LeSC.jpg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17" t="7143" r="4493" b="4078"/>
          <a:stretch/>
        </p:blipFill>
        <p:spPr>
          <a:xfrm>
            <a:off x="-5954" y="2399031"/>
            <a:ext cx="1697505" cy="1728216"/>
          </a:xfrm>
          <a:prstGeom prst="rect">
            <a:avLst/>
          </a:prstGeom>
        </p:spPr>
      </p:pic>
      <p:pic>
        <p:nvPicPr>
          <p:cNvPr id="3" name="Picture 2" descr="CD90-LeV.jpg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56" t="8318" r="4602" b="4511"/>
          <a:stretch/>
        </p:blipFill>
        <p:spPr>
          <a:xfrm>
            <a:off x="1691551" y="2433066"/>
            <a:ext cx="1689825" cy="1694181"/>
          </a:xfrm>
          <a:prstGeom prst="rect">
            <a:avLst/>
          </a:prstGeom>
        </p:spPr>
      </p:pic>
      <p:pic>
        <p:nvPicPr>
          <p:cNvPr id="29" name="Picture 28" descr="CD90-ObSC.jpg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56" t="7518" r="4384" b="4467"/>
          <a:stretch/>
        </p:blipFill>
        <p:spPr>
          <a:xfrm>
            <a:off x="3426215" y="2433066"/>
            <a:ext cx="1679185" cy="1695448"/>
          </a:xfrm>
          <a:prstGeom prst="rect">
            <a:avLst/>
          </a:prstGeom>
        </p:spPr>
      </p:pic>
      <p:pic>
        <p:nvPicPr>
          <p:cNvPr id="30" name="Picture 29" descr="CD90-OBV.jpg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56" t="8319" r="4822" b="4958"/>
          <a:stretch/>
        </p:blipFill>
        <p:spPr>
          <a:xfrm>
            <a:off x="5104067" y="2433066"/>
            <a:ext cx="1715833" cy="1715833"/>
          </a:xfrm>
          <a:prstGeom prst="rect">
            <a:avLst/>
          </a:prstGeom>
        </p:spPr>
      </p:pic>
      <p:pic>
        <p:nvPicPr>
          <p:cNvPr id="31" name="Picture 30" descr="CD105 LeSC.jpg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63" t="8544" r="4877" b="4958"/>
          <a:stretch/>
        </p:blipFill>
        <p:spPr>
          <a:xfrm>
            <a:off x="25959" y="4349734"/>
            <a:ext cx="1598052" cy="1585726"/>
          </a:xfrm>
          <a:prstGeom prst="rect">
            <a:avLst/>
          </a:prstGeom>
        </p:spPr>
      </p:pic>
      <p:pic>
        <p:nvPicPr>
          <p:cNvPr id="32" name="Picture 31" descr="CD105-LeV.jp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10" t="8354" r="4849" b="4735"/>
          <a:stretch/>
        </p:blipFill>
        <p:spPr>
          <a:xfrm>
            <a:off x="1733553" y="4370566"/>
            <a:ext cx="1647823" cy="1647160"/>
          </a:xfrm>
          <a:prstGeom prst="rect">
            <a:avLst/>
          </a:prstGeom>
        </p:spPr>
      </p:pic>
      <p:pic>
        <p:nvPicPr>
          <p:cNvPr id="33" name="Picture 32" descr="CD105 OBSC.jpg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548" t="8543" r="4575" b="4734"/>
          <a:stretch/>
        </p:blipFill>
        <p:spPr>
          <a:xfrm>
            <a:off x="3427548" y="4402554"/>
            <a:ext cx="1677852" cy="1676769"/>
          </a:xfrm>
          <a:prstGeom prst="rect">
            <a:avLst/>
          </a:prstGeom>
        </p:spPr>
      </p:pic>
      <p:pic>
        <p:nvPicPr>
          <p:cNvPr id="34" name="Picture 33" descr="CD105-ObV.png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56" t="8768" r="4390" b="2493"/>
          <a:stretch/>
        </p:blipFill>
        <p:spPr>
          <a:xfrm>
            <a:off x="5137404" y="4402554"/>
            <a:ext cx="1682496" cy="16824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1909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00</TotalTime>
  <Words>62</Words>
  <Application>Microsoft Macintosh PowerPoint</Application>
  <PresentationFormat>On-screen Show (4:3)</PresentationFormat>
  <Paragraphs>1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MDAC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 Zhang</dc:creator>
  <cp:lastModifiedBy>Yan Zhang</cp:lastModifiedBy>
  <cp:revision>102</cp:revision>
  <dcterms:created xsi:type="dcterms:W3CDTF">2014-09-04T20:58:07Z</dcterms:created>
  <dcterms:modified xsi:type="dcterms:W3CDTF">2015-08-09T07:13:04Z</dcterms:modified>
</cp:coreProperties>
</file>